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84" autoAdjust="0"/>
    <p:restoredTop sz="94660"/>
  </p:normalViewPr>
  <p:slideViewPr>
    <p:cSldViewPr snapToGrid="0">
      <p:cViewPr>
        <p:scale>
          <a:sx n="60" d="100"/>
          <a:sy n="60" d="100"/>
        </p:scale>
        <p:origin x="1248" y="5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4172A7-130F-BAE3-87FE-A84634B2F3F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EE11844-595C-D33D-BFE0-44574E2883B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6F4A51-1578-A4DA-4CE4-B390A3C2C5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7C841-6C26-4061-8BAA-17741BF2EFD0}" type="datetimeFigureOut">
              <a:rPr lang="fr-FR" smtClean="0"/>
              <a:t>30/04/2026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A5E7A7-3847-608E-70F0-EB13F44181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66715C-1505-B471-E828-D377622ADF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DBFFD2-A703-4151-9422-B1C624020CA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729516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31082A-CFA8-E71B-0F46-DC87817657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D788A87-84EA-F7B9-EDA4-11141667077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6F8450-3F90-5AC5-FE5A-D33A0D724D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7C841-6C26-4061-8BAA-17741BF2EFD0}" type="datetimeFigureOut">
              <a:rPr lang="fr-FR" smtClean="0"/>
              <a:t>30/04/2026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4428E9-3216-69AD-E507-84656165CD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721AF4-5F77-5B32-787D-ADBF602C7C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DBFFD2-A703-4151-9422-B1C624020CA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71868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F4558A8-D325-90BE-922B-F00321919C9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2431DC5-EB3F-DDF1-6FD9-4A4993B240E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7FDD5C1-E4E6-33A2-96C0-7019B4F6F5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7C841-6C26-4061-8BAA-17741BF2EFD0}" type="datetimeFigureOut">
              <a:rPr lang="fr-FR" smtClean="0"/>
              <a:t>30/04/2026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3DDFE2-31D9-90DB-F8C0-DC7416818A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2D0046-38ED-A681-568E-F94F829980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DBFFD2-A703-4151-9422-B1C624020CA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661698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FF3B63-F16E-8FD2-1B53-EF33B3B8C3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E8550D4-9F0B-7A61-B829-2A0353E8980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E95ED6-9391-5369-869C-2AA70B45AC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7C841-6C26-4061-8BAA-17741BF2EFD0}" type="datetimeFigureOut">
              <a:rPr lang="fr-FR" smtClean="0"/>
              <a:t>30/04/2026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C446C4-D8F0-60C3-8D99-96B8820C4F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7757ED-2AD0-1E8F-9F29-F90DAC691C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DBFFD2-A703-4151-9422-B1C624020CA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548154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25DC2D-97E4-6A4F-DEE4-94B66A3729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3A8BFEF-E2F3-0DB6-C58A-13CC612899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5936D6-843E-90E6-CFFB-712E9316A2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7C841-6C26-4061-8BAA-17741BF2EFD0}" type="datetimeFigureOut">
              <a:rPr lang="fr-FR" smtClean="0"/>
              <a:t>30/04/2026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9A98E3-23FA-7CED-EB88-2A9209C6F1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67F2F2-394D-257F-D43E-B13FF3AF85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DBFFD2-A703-4151-9422-B1C624020CA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278610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217A64-B7B6-D4DD-C77D-1166B077EA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38122DB-0F0A-D22C-1D9B-6725E152287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A2D1F23-2047-2AA8-1B8A-30C0B9D344B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EE45173-3B1A-95DC-BA90-B35136CB99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7C841-6C26-4061-8BAA-17741BF2EFD0}" type="datetimeFigureOut">
              <a:rPr lang="fr-FR" smtClean="0"/>
              <a:t>30/04/2026</a:t>
            </a:fld>
            <a:endParaRPr lang="fr-F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E81CE63-7BE1-F2E8-5825-354143F85B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A5B18C8-F144-A810-9047-055D527D5A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DBFFD2-A703-4151-9422-B1C624020CA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664096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E637D1-3DAB-EEDF-5ECF-9BA96BE2C4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0F38FC3-BF45-6B92-9801-2B7FE10F99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A017A8B-27CB-9170-A609-4C29030244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A2F3799-E2AA-DD9D-D343-1910AEA23AA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25A674C-8B7A-1F02-04F4-FD2AC3C18FB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DD7A28B-415D-EFE6-C729-980DC3AE78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7C841-6C26-4061-8BAA-17741BF2EFD0}" type="datetimeFigureOut">
              <a:rPr lang="fr-FR" smtClean="0"/>
              <a:t>30/04/2026</a:t>
            </a:fld>
            <a:endParaRPr lang="fr-FR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70FDEF1-952C-AA88-4EC8-271477F268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E79F28B-C5DE-F3FB-5355-9D5882D172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DBFFD2-A703-4151-9422-B1C624020CA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600684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262D0C-C38C-3557-389D-380C9881B0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22CB2DB-0132-2F24-A7D5-4F763EA1DA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7C841-6C26-4061-8BAA-17741BF2EFD0}" type="datetimeFigureOut">
              <a:rPr lang="fr-FR" smtClean="0"/>
              <a:t>30/04/2026</a:t>
            </a:fld>
            <a:endParaRPr lang="fr-FR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313803D-FFC6-204D-1B5C-14BAA844B3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C7F9813-A2C5-C381-3C27-BEA13D640C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DBFFD2-A703-4151-9422-B1C624020CA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260091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F58B354-4F72-A957-D378-62B32506B0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7C841-6C26-4061-8BAA-17741BF2EFD0}" type="datetimeFigureOut">
              <a:rPr lang="fr-FR" smtClean="0"/>
              <a:t>30/04/2026</a:t>
            </a:fld>
            <a:endParaRPr lang="fr-FR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A433028-BF89-70CC-5CE6-099E74E51B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139D0E2-111C-0676-514E-26EAB4B1BD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DBFFD2-A703-4151-9422-B1C624020CA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755572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ADDE9F-4A69-FCA1-FD15-8B5C03A408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124E245-3025-A949-A91A-1ED12E252BF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3ABA934-2BF5-16B5-EE12-1648A4B024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06BF9E6-682C-F843-8A9B-5C11C67C45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7C841-6C26-4061-8BAA-17741BF2EFD0}" type="datetimeFigureOut">
              <a:rPr lang="fr-FR" smtClean="0"/>
              <a:t>30/04/2026</a:t>
            </a:fld>
            <a:endParaRPr lang="fr-F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3799406-E395-C73E-B425-388A1276FD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E9AD0F8-5304-E93A-95CE-0A0E354EDB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DBFFD2-A703-4151-9422-B1C624020CA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799160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8C38A9-BDCF-0AD1-9147-C43069FDA4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B71C39A-F40B-9F93-2C77-FE9DB9066C9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20D70D6-B5EA-DBA8-1C81-093AAAF73D7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E114D59-5CB4-DA01-7394-F6DECDA818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7C841-6C26-4061-8BAA-17741BF2EFD0}" type="datetimeFigureOut">
              <a:rPr lang="fr-FR" smtClean="0"/>
              <a:t>30/04/2026</a:t>
            </a:fld>
            <a:endParaRPr lang="fr-F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B3A4F3A-CE09-259B-BBD9-882CDA7B59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DB627F0-B115-27D6-593B-9F74C444FE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DBFFD2-A703-4151-9422-B1C624020CA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871347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8515AA4-20A9-607F-DA6E-A259A23BE7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00EBB1E-3502-DE04-1C6D-4C4C5BC7FC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F86C81-CC6E-B2E0-B708-576E0FFB1BF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97C841-6C26-4061-8BAA-17741BF2EFD0}" type="datetimeFigureOut">
              <a:rPr lang="fr-FR" smtClean="0"/>
              <a:t>30/04/2026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69F738-DA45-D142-D741-FFD5681109D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55FF60-990D-D14A-EDD1-59CE5F2BC6E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DBFFD2-A703-4151-9422-B1C624020CA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092739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AutoShape 2">
            <a:extLst>
              <a:ext uri="{FF2B5EF4-FFF2-40B4-BE49-F238E27FC236}">
                <a16:creationId xmlns:a16="http://schemas.microsoft.com/office/drawing/2014/main" id="{C44994C0-2267-1147-74C8-B1CF1A272CC8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6096000" y="3453678"/>
            <a:ext cx="304800" cy="304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7" name="AutoShape 8">
            <a:extLst>
              <a:ext uri="{FF2B5EF4-FFF2-40B4-BE49-F238E27FC236}">
                <a16:creationId xmlns:a16="http://schemas.microsoft.com/office/drawing/2014/main" id="{8F9290F4-022A-B74C-7660-20801385BFB0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2663687" y="3428999"/>
            <a:ext cx="3737113" cy="37371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BFCC82A8-80E0-5F3C-4DA9-A3B3C0FFE91B}"/>
              </a:ext>
            </a:extLst>
          </p:cNvPr>
          <p:cNvSpPr/>
          <p:nvPr/>
        </p:nvSpPr>
        <p:spPr bwMode="auto">
          <a:xfrm>
            <a:off x="212035" y="927651"/>
            <a:ext cx="1444487" cy="59634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algn="l"/>
            <a:endParaRPr lang="fr-FR" dirty="0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12B5073C-0967-6C05-570E-35937B063894}"/>
              </a:ext>
            </a:extLst>
          </p:cNvPr>
          <p:cNvSpPr/>
          <p:nvPr/>
        </p:nvSpPr>
        <p:spPr bwMode="auto">
          <a:xfrm>
            <a:off x="130271" y="3700499"/>
            <a:ext cx="1133062" cy="357809"/>
          </a:xfrm>
          <a:prstGeom prst="rect">
            <a:avLst/>
          </a:prstGeom>
          <a:solidFill>
            <a:schemeClr val="bg1"/>
          </a:solidFill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algn="ctr"/>
            <a:r>
              <a:rPr lang="fr-FR" dirty="0"/>
              <a:t>Education</a:t>
            </a: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DB3DCB6C-DBE0-2A23-06B4-FB0F7251340B}"/>
              </a:ext>
            </a:extLst>
          </p:cNvPr>
          <p:cNvSpPr/>
          <p:nvPr/>
        </p:nvSpPr>
        <p:spPr bwMode="auto">
          <a:xfrm>
            <a:off x="122437" y="5076288"/>
            <a:ext cx="1133062" cy="357809"/>
          </a:xfrm>
          <a:prstGeom prst="rect">
            <a:avLst/>
          </a:prstGeom>
          <a:solidFill>
            <a:schemeClr val="bg1"/>
          </a:solidFill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algn="ctr"/>
            <a:r>
              <a:rPr lang="fr-FR" dirty="0"/>
              <a:t>LEDD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0CD6C204-5B4C-BD29-9C6E-E8B9911DA35E}"/>
              </a:ext>
            </a:extLst>
          </p:cNvPr>
          <p:cNvSpPr/>
          <p:nvPr/>
        </p:nvSpPr>
        <p:spPr bwMode="auto">
          <a:xfrm>
            <a:off x="6101873" y="2303341"/>
            <a:ext cx="1133062" cy="357809"/>
          </a:xfrm>
          <a:prstGeom prst="rect">
            <a:avLst/>
          </a:prstGeom>
          <a:solidFill>
            <a:schemeClr val="bg1"/>
          </a:solidFill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algn="r"/>
            <a:r>
              <a:rPr lang="fr-FR" dirty="0"/>
              <a:t>LEDD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4CFE9688-5217-4E17-C2C1-50B2773336F8}"/>
              </a:ext>
            </a:extLst>
          </p:cNvPr>
          <p:cNvSpPr/>
          <p:nvPr/>
        </p:nvSpPr>
        <p:spPr bwMode="auto">
          <a:xfrm>
            <a:off x="5397738" y="1520977"/>
            <a:ext cx="1808722" cy="239666"/>
          </a:xfrm>
          <a:prstGeom prst="rect">
            <a:avLst/>
          </a:prstGeom>
          <a:solidFill>
            <a:schemeClr val="bg1"/>
          </a:solidFill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algn="r">
              <a:lnSpc>
                <a:spcPts val="1500"/>
              </a:lnSpc>
            </a:pPr>
            <a:r>
              <a:rPr lang="fr-FR" dirty="0" err="1"/>
              <a:t>Disease</a:t>
            </a:r>
            <a:r>
              <a:rPr lang="fr-FR" dirty="0"/>
              <a:t> </a:t>
            </a:r>
          </a:p>
          <a:p>
            <a:pPr algn="r">
              <a:lnSpc>
                <a:spcPts val="1500"/>
              </a:lnSpc>
            </a:pPr>
            <a:r>
              <a:rPr lang="fr-FR" dirty="0"/>
              <a:t>duration</a:t>
            </a: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ED40114D-8FAD-5B59-2CAE-6D9E0D5FD500}"/>
              </a:ext>
            </a:extLst>
          </p:cNvPr>
          <p:cNvSpPr/>
          <p:nvPr/>
        </p:nvSpPr>
        <p:spPr bwMode="auto">
          <a:xfrm>
            <a:off x="6119729" y="1946105"/>
            <a:ext cx="1133062" cy="357809"/>
          </a:xfrm>
          <a:prstGeom prst="rect">
            <a:avLst/>
          </a:prstGeom>
          <a:solidFill>
            <a:schemeClr val="bg1"/>
          </a:solidFill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algn="r"/>
            <a:r>
              <a:rPr lang="fr-FR" dirty="0"/>
              <a:t>Education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F1168BE9-F5D5-B069-7D5E-7024360CD54C}"/>
              </a:ext>
            </a:extLst>
          </p:cNvPr>
          <p:cNvSpPr/>
          <p:nvPr/>
        </p:nvSpPr>
        <p:spPr bwMode="auto">
          <a:xfrm>
            <a:off x="6022561" y="737929"/>
            <a:ext cx="1133062" cy="357809"/>
          </a:xfrm>
          <a:prstGeom prst="rect">
            <a:avLst/>
          </a:prstGeom>
          <a:solidFill>
            <a:schemeClr val="bg1"/>
          </a:solidFill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algn="r"/>
            <a:r>
              <a:rPr lang="fr-FR" dirty="0"/>
              <a:t>Distance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A7FA4DA3-226D-4A8E-E0E9-4C17B512FAE4}"/>
              </a:ext>
            </a:extLst>
          </p:cNvPr>
          <p:cNvSpPr/>
          <p:nvPr/>
        </p:nvSpPr>
        <p:spPr bwMode="auto">
          <a:xfrm>
            <a:off x="6078349" y="1141679"/>
            <a:ext cx="1133062" cy="357809"/>
          </a:xfrm>
          <a:prstGeom prst="rect">
            <a:avLst/>
          </a:prstGeom>
          <a:solidFill>
            <a:schemeClr val="bg1"/>
          </a:solidFill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algn="r"/>
            <a:r>
              <a:rPr lang="fr-FR" dirty="0"/>
              <a:t>Age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51F2200F-4B99-41B2-EEDE-8D91580D021E}"/>
              </a:ext>
            </a:extLst>
          </p:cNvPr>
          <p:cNvSpPr txBox="1"/>
          <p:nvPr/>
        </p:nvSpPr>
        <p:spPr>
          <a:xfrm>
            <a:off x="275183" y="251791"/>
            <a:ext cx="533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b="1" dirty="0"/>
              <a:t>A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E38A7317-8349-2570-3101-554387C8CC1F}"/>
              </a:ext>
            </a:extLst>
          </p:cNvPr>
          <p:cNvSpPr txBox="1"/>
          <p:nvPr/>
        </p:nvSpPr>
        <p:spPr>
          <a:xfrm>
            <a:off x="6149212" y="151539"/>
            <a:ext cx="63259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2400" b="1" dirty="0"/>
              <a:t>B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2EBEB392-287B-6870-0431-D90AEBEB369E}"/>
              </a:ext>
            </a:extLst>
          </p:cNvPr>
          <p:cNvSpPr txBox="1"/>
          <p:nvPr/>
        </p:nvSpPr>
        <p:spPr>
          <a:xfrm>
            <a:off x="6129462" y="3365502"/>
            <a:ext cx="477078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2400" b="1" dirty="0"/>
              <a:t>C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3E9CBBDE-6455-FAC6-2560-76BC2FF3FABA}"/>
              </a:ext>
            </a:extLst>
          </p:cNvPr>
          <p:cNvSpPr txBox="1"/>
          <p:nvPr/>
        </p:nvSpPr>
        <p:spPr>
          <a:xfrm>
            <a:off x="8609077" y="5899967"/>
            <a:ext cx="1938008" cy="36933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fr-FR" dirty="0"/>
              <a:t>Propensity score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7947F4A6-FFAC-B33A-EA0C-375EDF5DCF1C}"/>
              </a:ext>
            </a:extLst>
          </p:cNvPr>
          <p:cNvSpPr txBox="1"/>
          <p:nvPr/>
        </p:nvSpPr>
        <p:spPr>
          <a:xfrm>
            <a:off x="7400096" y="2847539"/>
            <a:ext cx="423455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dirty="0" err="1"/>
              <a:t>Absolute</a:t>
            </a:r>
            <a:r>
              <a:rPr lang="fr-FR" dirty="0"/>
              <a:t> </a:t>
            </a:r>
            <a:r>
              <a:rPr lang="fr-FR" dirty="0" err="1"/>
              <a:t>Standardized</a:t>
            </a:r>
            <a:r>
              <a:rPr lang="fr-FR" dirty="0"/>
              <a:t> Mean Differences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769C6B1C-1C9C-E930-1594-5FE0D5F83BEA}"/>
              </a:ext>
            </a:extLst>
          </p:cNvPr>
          <p:cNvSpPr txBox="1"/>
          <p:nvPr/>
        </p:nvSpPr>
        <p:spPr>
          <a:xfrm>
            <a:off x="1683015" y="6214939"/>
            <a:ext cx="3405808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eCDF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E60FB3C-325A-6C06-ACC6-257672679EA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671" t="12795" b="56350"/>
          <a:stretch/>
        </p:blipFill>
        <p:spPr>
          <a:xfrm>
            <a:off x="1128658" y="4715893"/>
            <a:ext cx="4514522" cy="150555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01858555-E9FE-6455-1789-EB135586ABA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376" t="5127" b="2956"/>
          <a:stretch/>
        </p:blipFill>
        <p:spPr>
          <a:xfrm>
            <a:off x="1197673" y="317927"/>
            <a:ext cx="4432255" cy="4446226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A3C2D887-49FB-7A72-3B0A-F3D6BFF81624}"/>
              </a:ext>
            </a:extLst>
          </p:cNvPr>
          <p:cNvSpPr/>
          <p:nvPr/>
        </p:nvSpPr>
        <p:spPr bwMode="auto">
          <a:xfrm>
            <a:off x="264663" y="1054999"/>
            <a:ext cx="933010" cy="407368"/>
          </a:xfrm>
          <a:prstGeom prst="rect">
            <a:avLst/>
          </a:prstGeom>
          <a:solidFill>
            <a:schemeClr val="bg1"/>
          </a:solidFill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algn="ctr"/>
            <a:r>
              <a:rPr lang="fr-FR" dirty="0"/>
              <a:t>Age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82A78A02-FFE7-3F36-51FA-4B76AC535BBF}"/>
              </a:ext>
            </a:extLst>
          </p:cNvPr>
          <p:cNvSpPr/>
          <p:nvPr/>
        </p:nvSpPr>
        <p:spPr bwMode="auto">
          <a:xfrm>
            <a:off x="121679" y="2249713"/>
            <a:ext cx="1133062" cy="721079"/>
          </a:xfrm>
          <a:prstGeom prst="rect">
            <a:avLst/>
          </a:prstGeom>
          <a:solidFill>
            <a:schemeClr val="bg1"/>
          </a:solidFill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algn="ctr"/>
            <a:r>
              <a:rPr lang="fr-FR" dirty="0"/>
              <a:t>Disease duration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E7F70896-EF74-7705-20E4-319F629A21C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622" r="20756" b="14248"/>
          <a:stretch/>
        </p:blipFill>
        <p:spPr>
          <a:xfrm>
            <a:off x="7317941" y="403723"/>
            <a:ext cx="3985059" cy="2517277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08D70E69-A72B-3B71-B8DC-E3E099A8841E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644" r="15632" b="7383"/>
          <a:stretch/>
        </p:blipFill>
        <p:spPr>
          <a:xfrm>
            <a:off x="6825960" y="3460828"/>
            <a:ext cx="4958140" cy="2464905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8A8FA408-6F67-C6DA-5041-72E332F4A64C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451" t="41032" b="40481"/>
          <a:stretch/>
        </p:blipFill>
        <p:spPr>
          <a:xfrm>
            <a:off x="11286067" y="1558724"/>
            <a:ext cx="961081" cy="5426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18218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 bwMode="auto">
        <a:noFill/>
        <a:extLst>
          <a:ext uri="{909E8E84-426E-40DD-AFC4-6F175D3DCCD1}">
            <a14:hiddenFill xmlns:a14="http://schemas.microsoft.com/office/drawing/2010/main">
              <a:solidFill>
                <a:srgbClr val="FFFFFF"/>
              </a:solidFill>
            </a14:hiddenFill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algn="l">
          <a:defRPr dirty="0"/>
        </a:defPPr>
      </a:lstStyle>
    </a:sp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63</TotalTime>
  <Words>21</Words>
  <Application>Microsoft Office PowerPoint</Application>
  <PresentationFormat>Widescreen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urent Cleret De Langavant</dc:creator>
  <cp:lastModifiedBy>Laurent Cleret De Langavant</cp:lastModifiedBy>
  <cp:revision>9</cp:revision>
  <dcterms:created xsi:type="dcterms:W3CDTF">2024-02-20T13:25:54Z</dcterms:created>
  <dcterms:modified xsi:type="dcterms:W3CDTF">2026-04-30T16:44:43Z</dcterms:modified>
</cp:coreProperties>
</file>